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56" r:id="rId3"/>
    <p:sldId id="257" r:id="rId4"/>
    <p:sldId id="258" r:id="rId5"/>
    <p:sldId id="259" r:id="rId6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1"/>
    <p:restoredTop sz="94626"/>
  </p:normalViewPr>
  <p:slideViewPr>
    <p:cSldViewPr snapToGrid="0">
      <p:cViewPr varScale="1">
        <p:scale>
          <a:sx n="121" d="100"/>
          <a:sy n="121" d="100"/>
        </p:scale>
        <p:origin x="744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C05DF6C-C444-3D8D-6F5C-C1207902C1E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45F3FD56-93F8-0B54-2EC6-E5BBB7D00AD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84E6B51-3DD7-0960-D9E8-5B8FD03BF3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90E778-35FD-4BA6-B3B1-DD704674A3C0}" type="datetimeFigureOut">
              <a:rPr lang="zh-CN" altLang="en-US" smtClean="0"/>
              <a:t>2025/4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3656D0E-B322-ACBA-A14C-AFA262023A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11BF376-EF76-1348-D3E2-8BDD972AD0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007CDD-0C2D-4D24-8A7C-7999E81C13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162134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5580AC8-C335-4185-5C04-63C28F4145C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BCDCA1B4-D779-B3EC-A661-5CF989657A0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BF3649A-F886-EABF-4224-FD59728E70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90E778-35FD-4BA6-B3B1-DD704674A3C0}" type="datetimeFigureOut">
              <a:rPr lang="zh-CN" altLang="en-US" smtClean="0"/>
              <a:t>2025/4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468C821-4A55-8A2F-A268-959BC65B35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E9E6CC0-201D-8F38-63F6-EA241AD4AA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007CDD-0C2D-4D24-8A7C-7999E81C13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405172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BC8A16DC-0551-B641-F31F-4C83CB6678F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820CA254-6CA3-CC6A-71D0-6938C864E8F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26F13FA-9D2E-BBA2-ADCD-1C0DDA533F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90E778-35FD-4BA6-B3B1-DD704674A3C0}" type="datetimeFigureOut">
              <a:rPr lang="zh-CN" altLang="en-US" smtClean="0"/>
              <a:t>2025/4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FE414D6-EDE5-9E79-AE60-E15AA4DD12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83CFEBC-9760-AC5C-C4C1-AF12B115C6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007CDD-0C2D-4D24-8A7C-7999E81C13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051936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265B5F2-5013-DC6A-EC7D-8384407F097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799232B4-55BC-46A7-5765-CBEF255CEC6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D0E0D21-F3BD-80F4-DBCC-E003A3AC2D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90E778-35FD-4BA6-B3B1-DD704674A3C0}" type="datetimeFigureOut">
              <a:rPr lang="zh-CN" altLang="en-US" smtClean="0"/>
              <a:t>2025/4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E68F23A-1765-3F12-1972-B65E807D02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D3008F8-AE54-F41B-F9B3-DCCFB173DB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007CDD-0C2D-4D24-8A7C-7999E81C13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580722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01615DA-101B-A348-BCE7-2196E9864A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50A93C1-3DFF-63D4-4031-E4DD9DDB03C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D3120C5-02F2-C248-AD65-188EDBC58A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90E778-35FD-4BA6-B3B1-DD704674A3C0}" type="datetimeFigureOut">
              <a:rPr lang="zh-CN" altLang="en-US" smtClean="0"/>
              <a:t>2025/4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8CE24F5-082F-951A-46CC-CF46F500E0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9C8FD85-71E2-131C-6CB0-EB33A257D1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007CDD-0C2D-4D24-8A7C-7999E81C13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206514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2CE5DDC-213A-9CBD-3D39-9CAE7C82A00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A030C34-DDB2-1A1C-65C2-E715D63BC10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3471DDFE-772A-6CDE-685D-B4AE0E4A53F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E5D1516-90A9-C501-0D86-C5A73B317F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90E778-35FD-4BA6-B3B1-DD704674A3C0}" type="datetimeFigureOut">
              <a:rPr lang="zh-CN" altLang="en-US" smtClean="0"/>
              <a:t>2025/4/1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8B0AEA7-F1E5-F54C-02F7-34E502774C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BDD7AD6D-BA9A-81B6-E779-08298F3D17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007CDD-0C2D-4D24-8A7C-7999E81C13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222400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63066D1-C211-F43A-C27D-89B57EC71A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12AA87E-9F8C-2D0F-A46A-87665F64786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84866DF6-B110-150C-A3C0-2EB421F5AC9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057BFE91-7C96-494D-DFBD-3E22DBC0DF2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9C870FC1-D52E-F34D-8212-0A9DA6D9DCC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0E5B2FB0-1AF0-A17B-E9E3-7A03450399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90E778-35FD-4BA6-B3B1-DD704674A3C0}" type="datetimeFigureOut">
              <a:rPr lang="zh-CN" altLang="en-US" smtClean="0"/>
              <a:t>2025/4/16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8DA77135-1C07-FB88-7B54-B53D260704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943BDFAE-ADED-41D6-2018-E18FDAC0D1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007CDD-0C2D-4D24-8A7C-7999E81C13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965817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0E7BAAF-FE1D-D90C-183C-6E5011A7042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333EA979-41DE-7F35-DB86-74E0534464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90E778-35FD-4BA6-B3B1-DD704674A3C0}" type="datetimeFigureOut">
              <a:rPr lang="zh-CN" altLang="en-US" smtClean="0"/>
              <a:t>2025/4/16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BE8A36AD-876A-BD9F-99F2-B6A0069C50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44B411C6-DA44-B7DA-EEF0-9289B9BC60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007CDD-0C2D-4D24-8A7C-7999E81C13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037331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85B267D2-506E-8C45-1636-EC1075DD38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90E778-35FD-4BA6-B3B1-DD704674A3C0}" type="datetimeFigureOut">
              <a:rPr lang="zh-CN" altLang="en-US" smtClean="0"/>
              <a:t>2025/4/16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4984AAD8-648E-0AEE-13D4-CF0895511A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F99BA074-0046-BD65-7765-F6DB773781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007CDD-0C2D-4D24-8A7C-7999E81C13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501413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CAEB540-6A19-F138-8156-78733FFFD44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BA4F582-D0A2-234A-5621-FE55166415A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85F49773-8747-C20D-C256-212C81AF485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378BFD5-69D1-2AD1-0DB5-421149E0EB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90E778-35FD-4BA6-B3B1-DD704674A3C0}" type="datetimeFigureOut">
              <a:rPr lang="zh-CN" altLang="en-US" smtClean="0"/>
              <a:t>2025/4/1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D41ED6E-A16A-0FA3-4656-D400749D15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D3E8FCA-F6FA-297A-42A7-210A9AF855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007CDD-0C2D-4D24-8A7C-7999E81C13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065113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EF8E0CC-AAB9-07A6-95A6-E42CDD8937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951C34BE-AAFA-BA9B-0E62-397BC4F5A54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22BDAD86-BA41-A720-FCEB-D93F394207D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EB3FBC6B-74AD-9F09-72CF-77EFEA9DE0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90E778-35FD-4BA6-B3B1-DD704674A3C0}" type="datetimeFigureOut">
              <a:rPr lang="zh-CN" altLang="en-US" smtClean="0"/>
              <a:t>2025/4/1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1D004BF-A5DE-0637-F940-58CAFD1E7E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AC409F0-55DB-87AF-06F5-101246D758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007CDD-0C2D-4D24-8A7C-7999E81C13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848065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8A2ECE5B-5858-2277-E8B2-4BC8FC3E31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37F4097-B236-7C3C-51A9-A2E2B992114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9C8F8FE-7B79-0394-2668-B4799C2B23D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90E778-35FD-4BA6-B3B1-DD704674A3C0}" type="datetimeFigureOut">
              <a:rPr lang="zh-CN" altLang="en-US" smtClean="0"/>
              <a:t>2025/4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D35A0F8-7A55-BAEC-8ACD-185FCC6895B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C70DE9E-6AE7-504A-4103-4A30AC3AC11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007CDD-0C2D-4D24-8A7C-7999E81C13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235064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0.png"/><Relationship Id="rId4" Type="http://schemas.openxmlformats.org/officeDocument/2006/relationships/image" Target="../media/image9.ti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0.png"/><Relationship Id="rId4" Type="http://schemas.openxmlformats.org/officeDocument/2006/relationships/image" Target="../media/image11.ti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0.png"/><Relationship Id="rId4" Type="http://schemas.openxmlformats.org/officeDocument/2006/relationships/image" Target="../media/image12.ti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0.png"/><Relationship Id="rId4" Type="http://schemas.openxmlformats.org/officeDocument/2006/relationships/image" Target="../media/image1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0ECDF1CE-7DBC-C33A-EB04-22EA196C2613}"/>
              </a:ext>
            </a:extLst>
          </p:cNvPr>
          <p:cNvSpPr txBox="1"/>
          <p:nvPr/>
        </p:nvSpPr>
        <p:spPr>
          <a:xfrm>
            <a:off x="2219373" y="1309568"/>
            <a:ext cx="11119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/>
              <a:t>FOXO1</a:t>
            </a:r>
            <a:endParaRPr lang="zh-CN" altLang="en-US" sz="1400" b="1" dirty="0"/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D52A45A3-13FA-F004-6C11-659B52860B5B}"/>
              </a:ext>
            </a:extLst>
          </p:cNvPr>
          <p:cNvSpPr txBox="1"/>
          <p:nvPr/>
        </p:nvSpPr>
        <p:spPr>
          <a:xfrm>
            <a:off x="2219373" y="1678900"/>
            <a:ext cx="102467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/>
              <a:t>GAPDH</a:t>
            </a:r>
            <a:endParaRPr lang="zh-CN" altLang="en-US" sz="1400" b="1" dirty="0"/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141E86A3-1F75-3686-748D-EB636FF4E108}"/>
              </a:ext>
            </a:extLst>
          </p:cNvPr>
          <p:cNvSpPr txBox="1"/>
          <p:nvPr/>
        </p:nvSpPr>
        <p:spPr>
          <a:xfrm>
            <a:off x="2265324" y="2178788"/>
            <a:ext cx="10667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/>
              <a:t>HIF-1</a:t>
            </a:r>
            <a:r>
              <a:rPr lang="el-GR" altLang="zh-CN" sz="1400" b="1" dirty="0"/>
              <a:t>α</a:t>
            </a:r>
            <a:endParaRPr lang="zh-CN" altLang="en-US" sz="1400" b="1" dirty="0"/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E372F21B-8A8D-9247-C8B9-FD28CF20ED63}"/>
              </a:ext>
            </a:extLst>
          </p:cNvPr>
          <p:cNvSpPr txBox="1"/>
          <p:nvPr/>
        </p:nvSpPr>
        <p:spPr>
          <a:xfrm>
            <a:off x="2220138" y="2548120"/>
            <a:ext cx="102467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/>
              <a:t>GAPDH</a:t>
            </a:r>
            <a:endParaRPr lang="zh-CN" altLang="en-US" sz="1400" b="1" dirty="0"/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84C5B9C8-4051-5802-A6B8-72FFD1605A09}"/>
              </a:ext>
            </a:extLst>
          </p:cNvPr>
          <p:cNvSpPr txBox="1"/>
          <p:nvPr/>
        </p:nvSpPr>
        <p:spPr>
          <a:xfrm>
            <a:off x="2265325" y="3042648"/>
            <a:ext cx="9189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/>
              <a:t>PHD2</a:t>
            </a:r>
            <a:endParaRPr lang="zh-CN" altLang="en-US" sz="1400" b="1" dirty="0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13061E84-B2AF-01B8-0F8C-3111B90ED76A}"/>
              </a:ext>
            </a:extLst>
          </p:cNvPr>
          <p:cNvSpPr txBox="1"/>
          <p:nvPr/>
        </p:nvSpPr>
        <p:spPr>
          <a:xfrm>
            <a:off x="2224733" y="3411980"/>
            <a:ext cx="102467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/>
              <a:t>GAPDH</a:t>
            </a:r>
            <a:endParaRPr lang="zh-CN" altLang="en-US" sz="1400" b="1" dirty="0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4B48915A-4E64-647A-94F2-AD43E5F27C7F}"/>
              </a:ext>
            </a:extLst>
          </p:cNvPr>
          <p:cNvSpPr txBox="1"/>
          <p:nvPr/>
        </p:nvSpPr>
        <p:spPr>
          <a:xfrm>
            <a:off x="2312802" y="3911868"/>
            <a:ext cx="8255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/>
              <a:t>Sirt1</a:t>
            </a:r>
            <a:endParaRPr lang="zh-CN" altLang="en-US" sz="1400" b="1" dirty="0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9CCD652F-65F1-BDFE-7639-8978896537DE}"/>
              </a:ext>
            </a:extLst>
          </p:cNvPr>
          <p:cNvSpPr txBox="1"/>
          <p:nvPr/>
        </p:nvSpPr>
        <p:spPr>
          <a:xfrm>
            <a:off x="2225498" y="4281200"/>
            <a:ext cx="102467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/>
              <a:t>GAPDH</a:t>
            </a:r>
            <a:endParaRPr lang="zh-CN" altLang="en-US" sz="1400" b="1" dirty="0"/>
          </a:p>
        </p:txBody>
      </p:sp>
      <p:pic>
        <p:nvPicPr>
          <p:cNvPr id="11" name="图片 10">
            <a:extLst>
              <a:ext uri="{FF2B5EF4-FFF2-40B4-BE49-F238E27FC236}">
                <a16:creationId xmlns:a16="http://schemas.microsoft.com/office/drawing/2014/main" id="{6324AA1D-B062-1755-ADA4-54D0B0E27FD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20848" y="3397920"/>
            <a:ext cx="1683988" cy="304794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9AB51C82-9410-CFDB-956A-0308A070870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011323" y="3042324"/>
            <a:ext cx="1703037" cy="312414"/>
          </a:xfrm>
          <a:prstGeom prst="rect">
            <a:avLst/>
          </a:prstGeom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FC270CDB-6E1B-EFFA-8A27-487C659958E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017038" y="3915408"/>
            <a:ext cx="1687798" cy="342893"/>
          </a:xfrm>
          <a:prstGeom prst="rect">
            <a:avLst/>
          </a:prstGeom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B03DEBE9-E992-1F70-9DA5-839E5C12CB2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020848" y="4300115"/>
            <a:ext cx="1714467" cy="320034"/>
          </a:xfrm>
          <a:prstGeom prst="rect">
            <a:avLst/>
          </a:prstGeom>
        </p:spPr>
      </p:pic>
      <p:pic>
        <p:nvPicPr>
          <p:cNvPr id="19" name="图片 18">
            <a:extLst>
              <a:ext uri="{FF2B5EF4-FFF2-40B4-BE49-F238E27FC236}">
                <a16:creationId xmlns:a16="http://schemas.microsoft.com/office/drawing/2014/main" id="{591D7F4F-8061-802F-231D-918DBD46A334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032278" y="1292947"/>
            <a:ext cx="1672558" cy="346703"/>
          </a:xfrm>
          <a:prstGeom prst="rect">
            <a:avLst/>
          </a:prstGeom>
        </p:spPr>
      </p:pic>
      <p:pic>
        <p:nvPicPr>
          <p:cNvPr id="21" name="图片 20">
            <a:extLst>
              <a:ext uri="{FF2B5EF4-FFF2-40B4-BE49-F238E27FC236}">
                <a16:creationId xmlns:a16="http://schemas.microsoft.com/office/drawing/2014/main" id="{FFA9E111-5CC4-FA9E-41C4-25462216E74F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020848" y="1694130"/>
            <a:ext cx="1691608" cy="316224"/>
          </a:xfrm>
          <a:prstGeom prst="rect">
            <a:avLst/>
          </a:prstGeom>
        </p:spPr>
      </p:pic>
      <p:pic>
        <p:nvPicPr>
          <p:cNvPr id="23" name="图片 22">
            <a:extLst>
              <a:ext uri="{FF2B5EF4-FFF2-40B4-BE49-F238E27FC236}">
                <a16:creationId xmlns:a16="http://schemas.microsoft.com/office/drawing/2014/main" id="{2E65D432-BBDC-A6ED-F80A-A35FC96583A2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026562" y="2113469"/>
            <a:ext cx="1703037" cy="323844"/>
          </a:xfrm>
          <a:prstGeom prst="rect">
            <a:avLst/>
          </a:prstGeom>
        </p:spPr>
      </p:pic>
      <p:pic>
        <p:nvPicPr>
          <p:cNvPr id="25" name="图片 24">
            <a:extLst>
              <a:ext uri="{FF2B5EF4-FFF2-40B4-BE49-F238E27FC236}">
                <a16:creationId xmlns:a16="http://schemas.microsoft.com/office/drawing/2014/main" id="{0F380172-D874-BDF4-441D-5613B25A39FB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011323" y="2486565"/>
            <a:ext cx="1699227" cy="32003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7318502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0ECDF1CE-7DBC-C33A-EB04-22EA196C2613}"/>
              </a:ext>
            </a:extLst>
          </p:cNvPr>
          <p:cNvSpPr txBox="1"/>
          <p:nvPr/>
        </p:nvSpPr>
        <p:spPr>
          <a:xfrm>
            <a:off x="2219373" y="1309568"/>
            <a:ext cx="11119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/>
              <a:t>FOXO1</a:t>
            </a:r>
            <a:endParaRPr lang="zh-CN" altLang="en-US" sz="1400" b="1" dirty="0"/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D52A45A3-13FA-F004-6C11-659B52860B5B}"/>
              </a:ext>
            </a:extLst>
          </p:cNvPr>
          <p:cNvSpPr txBox="1"/>
          <p:nvPr/>
        </p:nvSpPr>
        <p:spPr>
          <a:xfrm>
            <a:off x="2219373" y="1678900"/>
            <a:ext cx="102467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/>
              <a:t>GAPDH</a:t>
            </a:r>
            <a:endParaRPr lang="zh-CN" altLang="en-US" sz="1400" b="1" dirty="0"/>
          </a:p>
        </p:txBody>
      </p:sp>
      <p:pic>
        <p:nvPicPr>
          <p:cNvPr id="19" name="图片 18">
            <a:extLst>
              <a:ext uri="{FF2B5EF4-FFF2-40B4-BE49-F238E27FC236}">
                <a16:creationId xmlns:a16="http://schemas.microsoft.com/office/drawing/2014/main" id="{591D7F4F-8061-802F-231D-918DBD46A33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32278" y="1292947"/>
            <a:ext cx="1672558" cy="346703"/>
          </a:xfrm>
          <a:prstGeom prst="rect">
            <a:avLst/>
          </a:prstGeom>
        </p:spPr>
      </p:pic>
      <p:pic>
        <p:nvPicPr>
          <p:cNvPr id="21" name="图片 20">
            <a:extLst>
              <a:ext uri="{FF2B5EF4-FFF2-40B4-BE49-F238E27FC236}">
                <a16:creationId xmlns:a16="http://schemas.microsoft.com/office/drawing/2014/main" id="{FFA9E111-5CC4-FA9E-41C4-25462216E74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020848" y="1694130"/>
            <a:ext cx="1691608" cy="316224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E47A0CDD-A91B-FAE3-9C84-DFEF7CE82F7A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461" t="29889" r="43367" b="15823"/>
          <a:stretch/>
        </p:blipFill>
        <p:spPr>
          <a:xfrm>
            <a:off x="5932715" y="1186543"/>
            <a:ext cx="3227008" cy="3559628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B7592090-CBCF-30B6-8431-BFC26D18A100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07912" y="1463456"/>
            <a:ext cx="833821" cy="315288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9258188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141E86A3-1F75-3686-748D-EB636FF4E108}"/>
              </a:ext>
            </a:extLst>
          </p:cNvPr>
          <p:cNvSpPr txBox="1"/>
          <p:nvPr/>
        </p:nvSpPr>
        <p:spPr>
          <a:xfrm>
            <a:off x="2265324" y="2178788"/>
            <a:ext cx="10667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/>
              <a:t>HIF-1</a:t>
            </a:r>
            <a:r>
              <a:rPr lang="el-GR" altLang="zh-CN" sz="1400" b="1" dirty="0"/>
              <a:t>α</a:t>
            </a:r>
            <a:endParaRPr lang="zh-CN" altLang="en-US" sz="1400" b="1" dirty="0"/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E372F21B-8A8D-9247-C8B9-FD28CF20ED63}"/>
              </a:ext>
            </a:extLst>
          </p:cNvPr>
          <p:cNvSpPr txBox="1"/>
          <p:nvPr/>
        </p:nvSpPr>
        <p:spPr>
          <a:xfrm>
            <a:off x="2220138" y="2548120"/>
            <a:ext cx="102467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/>
              <a:t>GAPDH</a:t>
            </a:r>
            <a:endParaRPr lang="zh-CN" altLang="en-US" sz="1400" b="1" dirty="0"/>
          </a:p>
        </p:txBody>
      </p:sp>
      <p:pic>
        <p:nvPicPr>
          <p:cNvPr id="23" name="图片 22">
            <a:extLst>
              <a:ext uri="{FF2B5EF4-FFF2-40B4-BE49-F238E27FC236}">
                <a16:creationId xmlns:a16="http://schemas.microsoft.com/office/drawing/2014/main" id="{2E65D432-BBDC-A6ED-F80A-A35FC96583A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26562" y="2113469"/>
            <a:ext cx="1703037" cy="323844"/>
          </a:xfrm>
          <a:prstGeom prst="rect">
            <a:avLst/>
          </a:prstGeom>
        </p:spPr>
      </p:pic>
      <p:pic>
        <p:nvPicPr>
          <p:cNvPr id="25" name="图片 24">
            <a:extLst>
              <a:ext uri="{FF2B5EF4-FFF2-40B4-BE49-F238E27FC236}">
                <a16:creationId xmlns:a16="http://schemas.microsoft.com/office/drawing/2014/main" id="{0F380172-D874-BDF4-441D-5613B25A39F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011323" y="2486565"/>
            <a:ext cx="1699227" cy="320034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9E91BB87-E515-6DE3-1E72-03B3EC4E26F1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867" t="29847" r="44094" b="19457"/>
          <a:stretch/>
        </p:blipFill>
        <p:spPr>
          <a:xfrm>
            <a:off x="6096000" y="1135642"/>
            <a:ext cx="3232186" cy="3341914"/>
          </a:xfrm>
          <a:prstGeom prst="rect">
            <a:avLst/>
          </a:prstGeom>
        </p:spPr>
      </p:pic>
      <p:pic>
        <p:nvPicPr>
          <p:cNvPr id="2" name="图片 1">
            <a:extLst>
              <a:ext uri="{FF2B5EF4-FFF2-40B4-BE49-F238E27FC236}">
                <a16:creationId xmlns:a16="http://schemas.microsoft.com/office/drawing/2014/main" id="{805D58D7-93F1-A048-F040-7E20AC2F3662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07912" y="1463456"/>
            <a:ext cx="833821" cy="315288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6290476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84C5B9C8-4051-5802-A6B8-72FFD1605A09}"/>
              </a:ext>
            </a:extLst>
          </p:cNvPr>
          <p:cNvSpPr txBox="1"/>
          <p:nvPr/>
        </p:nvSpPr>
        <p:spPr>
          <a:xfrm>
            <a:off x="2265325" y="3042648"/>
            <a:ext cx="9189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/>
              <a:t>PHD2</a:t>
            </a:r>
            <a:endParaRPr lang="zh-CN" altLang="en-US" sz="1400" b="1" dirty="0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13061E84-B2AF-01B8-0F8C-3111B90ED76A}"/>
              </a:ext>
            </a:extLst>
          </p:cNvPr>
          <p:cNvSpPr txBox="1"/>
          <p:nvPr/>
        </p:nvSpPr>
        <p:spPr>
          <a:xfrm>
            <a:off x="2224733" y="3411980"/>
            <a:ext cx="102467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/>
              <a:t>GAPDH</a:t>
            </a:r>
            <a:endParaRPr lang="zh-CN" altLang="en-US" sz="1400" b="1" dirty="0"/>
          </a:p>
        </p:txBody>
      </p:sp>
      <p:pic>
        <p:nvPicPr>
          <p:cNvPr id="11" name="图片 10">
            <a:extLst>
              <a:ext uri="{FF2B5EF4-FFF2-40B4-BE49-F238E27FC236}">
                <a16:creationId xmlns:a16="http://schemas.microsoft.com/office/drawing/2014/main" id="{6324AA1D-B062-1755-ADA4-54D0B0E27FD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20848" y="3397920"/>
            <a:ext cx="1683988" cy="304794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9AB51C82-9410-CFDB-956A-0308A070870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011323" y="3042324"/>
            <a:ext cx="1703037" cy="312414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64764A04-8729-CC03-43F6-897B2162CA5F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548" t="30313" r="44589" b="17290"/>
          <a:stretch/>
        </p:blipFill>
        <p:spPr>
          <a:xfrm>
            <a:off x="6096000" y="980510"/>
            <a:ext cx="3377005" cy="3734313"/>
          </a:xfrm>
          <a:prstGeom prst="rect">
            <a:avLst/>
          </a:prstGeom>
        </p:spPr>
      </p:pic>
      <p:pic>
        <p:nvPicPr>
          <p:cNvPr id="2" name="图片 1">
            <a:extLst>
              <a:ext uri="{FF2B5EF4-FFF2-40B4-BE49-F238E27FC236}">
                <a16:creationId xmlns:a16="http://schemas.microsoft.com/office/drawing/2014/main" id="{F50ABBAA-027F-7D9D-83A9-BEDE5E1AC5F1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07912" y="1463456"/>
            <a:ext cx="833821" cy="315288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4746541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文本框 7">
            <a:extLst>
              <a:ext uri="{FF2B5EF4-FFF2-40B4-BE49-F238E27FC236}">
                <a16:creationId xmlns:a16="http://schemas.microsoft.com/office/drawing/2014/main" id="{4B48915A-4E64-647A-94F2-AD43E5F27C7F}"/>
              </a:ext>
            </a:extLst>
          </p:cNvPr>
          <p:cNvSpPr txBox="1"/>
          <p:nvPr/>
        </p:nvSpPr>
        <p:spPr>
          <a:xfrm>
            <a:off x="2312802" y="3911868"/>
            <a:ext cx="8255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/>
              <a:t>Sirt1</a:t>
            </a:r>
            <a:endParaRPr lang="zh-CN" altLang="en-US" sz="1400" b="1" dirty="0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9CCD652F-65F1-BDFE-7639-8978896537DE}"/>
              </a:ext>
            </a:extLst>
          </p:cNvPr>
          <p:cNvSpPr txBox="1"/>
          <p:nvPr/>
        </p:nvSpPr>
        <p:spPr>
          <a:xfrm>
            <a:off x="2225498" y="4281200"/>
            <a:ext cx="102467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/>
              <a:t>GAPDH</a:t>
            </a:r>
            <a:endParaRPr lang="zh-CN" altLang="en-US" sz="1400" b="1" dirty="0"/>
          </a:p>
        </p:txBody>
      </p:sp>
      <p:pic>
        <p:nvPicPr>
          <p:cNvPr id="15" name="图片 14">
            <a:extLst>
              <a:ext uri="{FF2B5EF4-FFF2-40B4-BE49-F238E27FC236}">
                <a16:creationId xmlns:a16="http://schemas.microsoft.com/office/drawing/2014/main" id="{FC270CDB-6E1B-EFFA-8A27-487C659958E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17038" y="3915408"/>
            <a:ext cx="1687798" cy="342893"/>
          </a:xfrm>
          <a:prstGeom prst="rect">
            <a:avLst/>
          </a:prstGeom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B03DEBE9-E992-1F70-9DA5-839E5C12CB2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020848" y="4300115"/>
            <a:ext cx="1714467" cy="320034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5A451AE0-4535-4FBA-A67F-876AE0AA58C3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753" t="28798" r="44156" b="17725"/>
          <a:stretch/>
        </p:blipFill>
        <p:spPr>
          <a:xfrm>
            <a:off x="6091298" y="750145"/>
            <a:ext cx="3094908" cy="3469499"/>
          </a:xfrm>
          <a:prstGeom prst="rect">
            <a:avLst/>
          </a:prstGeom>
        </p:spPr>
      </p:pic>
      <p:pic>
        <p:nvPicPr>
          <p:cNvPr id="2" name="图片 1">
            <a:extLst>
              <a:ext uri="{FF2B5EF4-FFF2-40B4-BE49-F238E27FC236}">
                <a16:creationId xmlns:a16="http://schemas.microsoft.com/office/drawing/2014/main" id="{DF7A96F6-2672-78EC-E13A-B2F9701DFE02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07912" y="1463456"/>
            <a:ext cx="833821" cy="315288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041794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13</TotalTime>
  <Words>18</Words>
  <Application>Microsoft Macintosh PowerPoint</Application>
  <PresentationFormat>宽屏</PresentationFormat>
  <Paragraphs>16</Paragraphs>
  <Slides>5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9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yue zhuo</dc:creator>
  <cp:lastModifiedBy>DK//.WW</cp:lastModifiedBy>
  <cp:revision>6</cp:revision>
  <dcterms:created xsi:type="dcterms:W3CDTF">2024-07-31T06:23:35Z</dcterms:created>
  <dcterms:modified xsi:type="dcterms:W3CDTF">2025-04-16T07:00:49Z</dcterms:modified>
</cp:coreProperties>
</file>